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302" r:id="rId2"/>
    <p:sldId id="309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1"/>
    <p:restoredTop sz="94663"/>
  </p:normalViewPr>
  <p:slideViewPr>
    <p:cSldViewPr snapToGrid="0" snapToObjects="1" showGuides="1">
      <p:cViewPr>
        <p:scale>
          <a:sx n="151" d="100"/>
          <a:sy n="151" d="100"/>
        </p:scale>
        <p:origin x="288" y="14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678CEA-2CFF-B147-9B2A-2F435F19294F}" type="datetimeFigureOut">
              <a:rPr lang="en-US" smtClean="0"/>
              <a:t>5/27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0790F2-3F5B-BA49-948A-5F24AC6E5F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44645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678CEA-2CFF-B147-9B2A-2F435F19294F}" type="datetimeFigureOut">
              <a:rPr lang="en-US" smtClean="0"/>
              <a:t>5/27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0790F2-3F5B-BA49-948A-5F24AC6E5F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98945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678CEA-2CFF-B147-9B2A-2F435F19294F}" type="datetimeFigureOut">
              <a:rPr lang="en-US" smtClean="0"/>
              <a:t>5/27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0790F2-3F5B-BA49-948A-5F24AC6E5F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17234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678CEA-2CFF-B147-9B2A-2F435F19294F}" type="datetimeFigureOut">
              <a:rPr lang="en-US" smtClean="0"/>
              <a:t>5/27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0790F2-3F5B-BA49-948A-5F24AC6E5F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4895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678CEA-2CFF-B147-9B2A-2F435F19294F}" type="datetimeFigureOut">
              <a:rPr lang="en-US" smtClean="0"/>
              <a:t>5/27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0790F2-3F5B-BA49-948A-5F24AC6E5F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59911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678CEA-2CFF-B147-9B2A-2F435F19294F}" type="datetimeFigureOut">
              <a:rPr lang="en-US" smtClean="0"/>
              <a:t>5/27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0790F2-3F5B-BA49-948A-5F24AC6E5F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03714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678CEA-2CFF-B147-9B2A-2F435F19294F}" type="datetimeFigureOut">
              <a:rPr lang="en-US" smtClean="0"/>
              <a:t>5/27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0790F2-3F5B-BA49-948A-5F24AC6E5F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59712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678CEA-2CFF-B147-9B2A-2F435F19294F}" type="datetimeFigureOut">
              <a:rPr lang="en-US" smtClean="0"/>
              <a:t>5/27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0790F2-3F5B-BA49-948A-5F24AC6E5F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1558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678CEA-2CFF-B147-9B2A-2F435F19294F}" type="datetimeFigureOut">
              <a:rPr lang="en-US" smtClean="0"/>
              <a:t>5/27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0790F2-3F5B-BA49-948A-5F24AC6E5F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29907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678CEA-2CFF-B147-9B2A-2F435F19294F}" type="datetimeFigureOut">
              <a:rPr lang="en-US" smtClean="0"/>
              <a:t>5/27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0790F2-3F5B-BA49-948A-5F24AC6E5F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48814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678CEA-2CFF-B147-9B2A-2F435F19294F}" type="datetimeFigureOut">
              <a:rPr lang="en-US" smtClean="0"/>
              <a:t>5/27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0790F2-3F5B-BA49-948A-5F24AC6E5F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06184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678CEA-2CFF-B147-9B2A-2F435F19294F}" type="datetimeFigureOut">
              <a:rPr lang="en-US" smtClean="0"/>
              <a:t>5/27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0790F2-3F5B-BA49-948A-5F24AC6E5F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31852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58D1E020-1BBA-034D-AA2E-E584D1AC7571}"/>
              </a:ext>
            </a:extLst>
          </p:cNvPr>
          <p:cNvGraphicFramePr>
            <a:graphicFrameLocks noGrp="1"/>
          </p:cNvGraphicFramePr>
          <p:nvPr/>
        </p:nvGraphicFramePr>
        <p:xfrm>
          <a:off x="314113" y="643890"/>
          <a:ext cx="6229773" cy="8496942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293876">
                  <a:extLst>
                    <a:ext uri="{9D8B030D-6E8A-4147-A177-3AD203B41FA5}">
                      <a16:colId xmlns:a16="http://schemas.microsoft.com/office/drawing/2014/main" val="1441026580"/>
                    </a:ext>
                  </a:extLst>
                </a:gridCol>
                <a:gridCol w="1150113">
                  <a:extLst>
                    <a:ext uri="{9D8B030D-6E8A-4147-A177-3AD203B41FA5}">
                      <a16:colId xmlns:a16="http://schemas.microsoft.com/office/drawing/2014/main" val="3282591095"/>
                    </a:ext>
                  </a:extLst>
                </a:gridCol>
                <a:gridCol w="3785784">
                  <a:extLst>
                    <a:ext uri="{9D8B030D-6E8A-4147-A177-3AD203B41FA5}">
                      <a16:colId xmlns:a16="http://schemas.microsoft.com/office/drawing/2014/main" val="3809054462"/>
                    </a:ext>
                  </a:extLst>
                </a:gridCol>
              </a:tblGrid>
              <a:tr h="292998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ecies </a:t>
                      </a:r>
                    </a:p>
                  </a:txBody>
                  <a:tcPr marL="121706" marR="12170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i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Ns</a:t>
                      </a:r>
                    </a:p>
                  </a:txBody>
                  <a:tcPr marL="121706" marR="12170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ordinate</a:t>
                      </a:r>
                    </a:p>
                  </a:txBody>
                  <a:tcPr marL="121706" marR="12170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90457495"/>
                  </a:ext>
                </a:extLst>
              </a:tr>
              <a:tr h="292998">
                <a:tc rowSpan="8">
                  <a:txBody>
                    <a:bodyPr/>
                    <a:lstStyle/>
                    <a:p>
                      <a:pPr algn="ctr"/>
                      <a:r>
                        <a:rPr lang="en-US" sz="1000" i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. albicans</a:t>
                      </a:r>
                    </a:p>
                  </a:txBody>
                  <a:tcPr marL="100584" marR="100584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121706" marR="12170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22chr1A_C_albicans_SC5314:1561401-1569971</a:t>
                      </a:r>
                      <a:endParaRPr lang="en-US" sz="1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21706" marR="12170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77476773"/>
                  </a:ext>
                </a:extLst>
              </a:tr>
              <a:tr h="292998">
                <a:tc vMerge="1">
                  <a:txBody>
                    <a:bodyPr/>
                    <a:lstStyle/>
                    <a:p>
                      <a:pPr algn="ctr"/>
                      <a:endParaRPr 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121706" marR="12170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22chr2A_C_albicans_SC5314:1923002-1930207</a:t>
                      </a:r>
                      <a:endParaRPr lang="en-US" sz="1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21706" marR="12170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14451240"/>
                  </a:ext>
                </a:extLst>
              </a:tr>
              <a:tr h="292998">
                <a:tc vMerge="1">
                  <a:txBody>
                    <a:bodyPr/>
                    <a:lstStyle/>
                    <a:p>
                      <a:pPr algn="ctr"/>
                      <a:endParaRPr 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121706" marR="12170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22chr3A_C_albicans_SC5314:822280-826495</a:t>
                      </a:r>
                      <a:endParaRPr lang="en-US" sz="1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21706" marR="12170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33267737"/>
                  </a:ext>
                </a:extLst>
              </a:tr>
              <a:tr h="292998">
                <a:tc vMerge="1">
                  <a:txBody>
                    <a:bodyPr/>
                    <a:lstStyle/>
                    <a:p>
                      <a:pPr algn="ctr"/>
                      <a:endParaRPr 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121706" marR="12170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22chr4A_C_albicans_SC5314:990403-998773</a:t>
                      </a:r>
                      <a:endParaRPr lang="en-US" sz="1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21706" marR="12170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98303469"/>
                  </a:ext>
                </a:extLst>
              </a:tr>
              <a:tr h="292998">
                <a:tc vMerge="1">
                  <a:txBody>
                    <a:bodyPr/>
                    <a:lstStyle/>
                    <a:p>
                      <a:pPr algn="ctr"/>
                      <a:endParaRPr 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</a:p>
                  </a:txBody>
                  <a:tcPr marL="121706" marR="12170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22chr5A_C_albicans_SC5314:467755-473497</a:t>
                      </a:r>
                      <a:endParaRPr lang="en-US" sz="1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21706" marR="12170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78138360"/>
                  </a:ext>
                </a:extLst>
              </a:tr>
              <a:tr h="292998">
                <a:tc vMerge="1">
                  <a:txBody>
                    <a:bodyPr/>
                    <a:lstStyle/>
                    <a:p>
                      <a:pPr algn="ctr"/>
                      <a:endParaRPr 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</a:p>
                  </a:txBody>
                  <a:tcPr marL="121706" marR="12170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22chr6A_C_albicans_SC5314:978304-983784</a:t>
                      </a:r>
                      <a:endParaRPr lang="en-US" sz="1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21706" marR="12170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41760391"/>
                  </a:ext>
                </a:extLst>
              </a:tr>
              <a:tr h="292998">
                <a:tc vMerge="1">
                  <a:txBody>
                    <a:bodyPr/>
                    <a:lstStyle/>
                    <a:p>
                      <a:pPr algn="ctr"/>
                      <a:endParaRPr 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</a:p>
                  </a:txBody>
                  <a:tcPr marL="121706" marR="12170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22chr7A_C_albicans_SC5314:423402-429940</a:t>
                      </a:r>
                      <a:endParaRPr lang="en-US" sz="1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21706" marR="12170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28798656"/>
                  </a:ext>
                </a:extLst>
              </a:tr>
              <a:tr h="292998">
                <a:tc vMerge="1">
                  <a:txBody>
                    <a:bodyPr/>
                    <a:lstStyle/>
                    <a:p>
                      <a:pPr algn="ctr"/>
                      <a:endParaRPr 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</a:p>
                  </a:txBody>
                  <a:tcPr marL="121706" marR="12170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22chrRA_C_albicans_SC5314:1741032-1748631</a:t>
                      </a:r>
                      <a:endParaRPr lang="en-US" sz="1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21706" marR="12170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28424942"/>
                  </a:ext>
                </a:extLst>
              </a:tr>
              <a:tr h="292998">
                <a:tc rowSpan="7">
                  <a:txBody>
                    <a:bodyPr/>
                    <a:lstStyle/>
                    <a:p>
                      <a:pPr algn="ctr"/>
                      <a:r>
                        <a:rPr lang="en-US" sz="1000" i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. tropicalis</a:t>
                      </a:r>
                    </a:p>
                  </a:txBody>
                  <a:tcPr marL="100584" marR="100584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121706" marR="12170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r1:466,066-475,754</a:t>
                      </a:r>
                    </a:p>
                  </a:txBody>
                  <a:tcPr marL="121706" marR="12170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17413156"/>
                  </a:ext>
                </a:extLst>
              </a:tr>
              <a:tr h="292998">
                <a:tc vMerge="1">
                  <a:txBody>
                    <a:bodyPr/>
                    <a:lstStyle/>
                    <a:p>
                      <a:pPr algn="ctr"/>
                      <a:endParaRPr 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121706" marR="12170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r2:725185-735300</a:t>
                      </a:r>
                    </a:p>
                  </a:txBody>
                  <a:tcPr marL="121706" marR="12170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41086430"/>
                  </a:ext>
                </a:extLst>
              </a:tr>
              <a:tr h="292998">
                <a:tc vMerge="1">
                  <a:txBody>
                    <a:bodyPr/>
                    <a:lstStyle/>
                    <a:p>
                      <a:pPr algn="ctr"/>
                      <a:endParaRPr 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121706" marR="12170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r3:952377-962681</a:t>
                      </a:r>
                    </a:p>
                  </a:txBody>
                  <a:tcPr marL="121706" marR="12170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9801728"/>
                  </a:ext>
                </a:extLst>
              </a:tr>
              <a:tr h="292998">
                <a:tc vMerge="1">
                  <a:txBody>
                    <a:bodyPr/>
                    <a:lstStyle/>
                    <a:p>
                      <a:pPr algn="ctr"/>
                      <a:endParaRPr 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121706" marR="12170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r4:906302-916031</a:t>
                      </a:r>
                    </a:p>
                  </a:txBody>
                  <a:tcPr marL="121706" marR="12170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48665239"/>
                  </a:ext>
                </a:extLst>
              </a:tr>
              <a:tr h="292998">
                <a:tc vMerge="1">
                  <a:txBody>
                    <a:bodyPr/>
                    <a:lstStyle/>
                    <a:p>
                      <a:pPr algn="ctr"/>
                      <a:endParaRPr 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</a:p>
                  </a:txBody>
                  <a:tcPr marL="121706" marR="12170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r5:594006-604320</a:t>
                      </a:r>
                    </a:p>
                  </a:txBody>
                  <a:tcPr marL="121706" marR="12170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58138428"/>
                  </a:ext>
                </a:extLst>
              </a:tr>
              <a:tr h="292998">
                <a:tc vMerge="1">
                  <a:txBody>
                    <a:bodyPr/>
                    <a:lstStyle/>
                    <a:p>
                      <a:pPr algn="ctr"/>
                      <a:endParaRPr 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</a:p>
                  </a:txBody>
                  <a:tcPr marL="121706" marR="12170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r6:308570-331012</a:t>
                      </a:r>
                    </a:p>
                  </a:txBody>
                  <a:tcPr marL="121706" marR="12170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74115025"/>
                  </a:ext>
                </a:extLst>
              </a:tr>
              <a:tr h="292998">
                <a:tc vMerge="1">
                  <a:txBody>
                    <a:bodyPr/>
                    <a:lstStyle/>
                    <a:p>
                      <a:pPr algn="ctr"/>
                      <a:endParaRPr 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</a:p>
                  </a:txBody>
                  <a:tcPr marL="121706" marR="12170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rR:855697-865834</a:t>
                      </a:r>
                    </a:p>
                  </a:txBody>
                  <a:tcPr marL="121706" marR="12170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28292062"/>
                  </a:ext>
                </a:extLst>
              </a:tr>
              <a:tr h="292998">
                <a:tc rowSpan="7">
                  <a:txBody>
                    <a:bodyPr/>
                    <a:lstStyle/>
                    <a:p>
                      <a:pPr algn="ctr"/>
                      <a:r>
                        <a:rPr lang="en-US" sz="1000" i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. </a:t>
                      </a:r>
                      <a:r>
                        <a:rPr lang="en-US" sz="1000" i="1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jae</a:t>
                      </a:r>
                      <a:endParaRPr lang="en-US" sz="1000" i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00584" marR="100584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121706" marR="12170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g2:2493969-2501301</a:t>
                      </a:r>
                    </a:p>
                  </a:txBody>
                  <a:tcPr marL="121706" marR="12170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49480290"/>
                  </a:ext>
                </a:extLst>
              </a:tr>
              <a:tr h="292998">
                <a:tc vMerge="1">
                  <a:txBody>
                    <a:bodyPr/>
                    <a:lstStyle/>
                    <a:p>
                      <a:pPr algn="ctr"/>
                      <a:endParaRPr 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121706" marR="12170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g8:1905358-1914164</a:t>
                      </a:r>
                    </a:p>
                  </a:txBody>
                  <a:tcPr marL="121706" marR="12170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54551822"/>
                  </a:ext>
                </a:extLst>
              </a:tr>
              <a:tr h="292998">
                <a:tc vMerge="1">
                  <a:txBody>
                    <a:bodyPr/>
                    <a:lstStyle/>
                    <a:p>
                      <a:pPr algn="ctr"/>
                      <a:endParaRPr 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121706" marR="12170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g38:934048-941518</a:t>
                      </a:r>
                    </a:p>
                  </a:txBody>
                  <a:tcPr marL="121706" marR="12170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70587506"/>
                  </a:ext>
                </a:extLst>
              </a:tr>
              <a:tr h="292998">
                <a:tc vMerge="1">
                  <a:txBody>
                    <a:bodyPr/>
                    <a:lstStyle/>
                    <a:p>
                      <a:pPr algn="ctr"/>
                      <a:endParaRPr 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121706" marR="12170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g17:1062429-1069512</a:t>
                      </a:r>
                    </a:p>
                  </a:txBody>
                  <a:tcPr marL="121706" marR="12170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15435795"/>
                  </a:ext>
                </a:extLst>
              </a:tr>
              <a:tr h="292998">
                <a:tc vMerge="1">
                  <a:txBody>
                    <a:bodyPr/>
                    <a:lstStyle/>
                    <a:p>
                      <a:pPr algn="ctr"/>
                      <a:endParaRPr 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</a:p>
                  </a:txBody>
                  <a:tcPr marL="121706" marR="12170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g50:549697-575759</a:t>
                      </a:r>
                    </a:p>
                  </a:txBody>
                  <a:tcPr marL="121706" marR="12170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44717970"/>
                  </a:ext>
                </a:extLst>
              </a:tr>
              <a:tr h="292998">
                <a:tc vMerge="1">
                  <a:txBody>
                    <a:bodyPr/>
                    <a:lstStyle/>
                    <a:p>
                      <a:pPr algn="ctr"/>
                      <a:endParaRPr 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</a:p>
                  </a:txBody>
                  <a:tcPr marL="121706" marR="12170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g16100:638309-647019</a:t>
                      </a:r>
                    </a:p>
                  </a:txBody>
                  <a:tcPr marL="121706" marR="12170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85740986"/>
                  </a:ext>
                </a:extLst>
              </a:tr>
              <a:tr h="292998">
                <a:tc vMerge="1">
                  <a:txBody>
                    <a:bodyPr/>
                    <a:lstStyle/>
                    <a:p>
                      <a:pPr algn="ctr"/>
                      <a:endParaRPr 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</a:p>
                  </a:txBody>
                  <a:tcPr marL="121706" marR="12170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g1:623000-630276</a:t>
                      </a:r>
                    </a:p>
                  </a:txBody>
                  <a:tcPr marL="121706" marR="12170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57617211"/>
                  </a:ext>
                </a:extLst>
              </a:tr>
              <a:tr h="292998">
                <a:tc rowSpan="6">
                  <a:txBody>
                    <a:bodyPr/>
                    <a:lstStyle/>
                    <a:p>
                      <a:pPr algn="ctr"/>
                      <a:r>
                        <a:rPr lang="en-US" sz="1000" i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. </a:t>
                      </a:r>
                      <a:r>
                        <a:rPr lang="en-US" sz="1000" i="1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iswanathii</a:t>
                      </a:r>
                      <a:endParaRPr lang="en-US" sz="1000" i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00584" marR="100584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121706" marR="12170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W_020797858.1:473076-485506</a:t>
                      </a:r>
                    </a:p>
                  </a:txBody>
                  <a:tcPr marL="121706" marR="12170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81664619"/>
                  </a:ext>
                </a:extLst>
              </a:tr>
              <a:tr h="292998">
                <a:tc vMerge="1">
                  <a:txBody>
                    <a:bodyPr/>
                    <a:lstStyle/>
                    <a:p>
                      <a:pPr algn="ctr"/>
                      <a:endParaRPr 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121706" marR="12170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W_020797886.1:1829726-1842348</a:t>
                      </a:r>
                    </a:p>
                  </a:txBody>
                  <a:tcPr marL="121706" marR="12170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68665132"/>
                  </a:ext>
                </a:extLst>
              </a:tr>
              <a:tr h="292998">
                <a:tc vMerge="1">
                  <a:txBody>
                    <a:bodyPr/>
                    <a:lstStyle/>
                    <a:p>
                      <a:pPr algn="ctr"/>
                      <a:endParaRPr 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121706" marR="12170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W_020797884.1:937333-949114</a:t>
                      </a:r>
                    </a:p>
                  </a:txBody>
                  <a:tcPr marL="121706" marR="12170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93340486"/>
                  </a:ext>
                </a:extLst>
              </a:tr>
              <a:tr h="292998">
                <a:tc vMerge="1">
                  <a:txBody>
                    <a:bodyPr/>
                    <a:lstStyle/>
                    <a:p>
                      <a:pPr algn="ctr"/>
                      <a:endParaRPr 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121706" marR="12170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W_020797885.1:1322147-1333995</a:t>
                      </a:r>
                    </a:p>
                  </a:txBody>
                  <a:tcPr marL="121706" marR="12170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47705010"/>
                  </a:ext>
                </a:extLst>
              </a:tr>
              <a:tr h="292998">
                <a:tc vMerge="1">
                  <a:txBody>
                    <a:bodyPr/>
                    <a:lstStyle/>
                    <a:p>
                      <a:pPr algn="ctr"/>
                      <a:endParaRPr 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</a:p>
                  </a:txBody>
                  <a:tcPr marL="121706" marR="12170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W_020797877.1:349856-362272</a:t>
                      </a:r>
                    </a:p>
                  </a:txBody>
                  <a:tcPr marL="121706" marR="12170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1911354"/>
                  </a:ext>
                </a:extLst>
              </a:tr>
              <a:tr h="292998">
                <a:tc vMerge="1">
                  <a:txBody>
                    <a:bodyPr/>
                    <a:lstStyle/>
                    <a:p>
                      <a:pPr algn="ctr"/>
                      <a:endParaRPr 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</a:p>
                  </a:txBody>
                  <a:tcPr marL="121706" marR="12170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W_020797881.1:1345731-1360763</a:t>
                      </a:r>
                    </a:p>
                  </a:txBody>
                  <a:tcPr marL="121706" marR="12170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94834814"/>
                  </a:ext>
                </a:extLst>
              </a:tr>
            </a:tbl>
          </a:graphicData>
        </a:graphic>
      </p:graphicFrame>
      <p:sp>
        <p:nvSpPr>
          <p:cNvPr id="5" name="Rectangle 2">
            <a:extLst>
              <a:ext uri="{FF2B5EF4-FFF2-40B4-BE49-F238E27FC236}">
                <a16:creationId xmlns:a16="http://schemas.microsoft.com/office/drawing/2014/main" id="{726CCC76-1E8C-D749-BB22-FA9EB5E7CDD5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836" y="272936"/>
            <a:ext cx="7287210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i="0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Supplementary file 7: Centromere coordinates used for identifying conserved DNA sequence motifs</a:t>
            </a:r>
            <a:r>
              <a:rPr kumimoji="0" lang="en-US" altLang="en-US" sz="1000" i="0" u="none" strike="noStrike" cap="none" normalizeH="0" dirty="0">
                <a:ln>
                  <a:noFill/>
                </a:ln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 in </a:t>
            </a:r>
            <a:r>
              <a:rPr kumimoji="0" lang="en-US" altLang="en-US" sz="1000" i="1" u="none" strike="noStrike" cap="none" normalizeH="0" dirty="0">
                <a:ln>
                  <a:noFill/>
                </a:ln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Candida</a:t>
            </a:r>
            <a:r>
              <a:rPr kumimoji="0" lang="en-US" altLang="en-US" sz="1000" i="0" u="none" strike="noStrike" cap="none" normalizeH="0" dirty="0">
                <a:ln>
                  <a:noFill/>
                </a:ln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 species</a:t>
            </a:r>
            <a:endParaRPr kumimoji="0" lang="en-US" altLang="en-US" sz="100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6386547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7E5BF277-2076-7947-886E-9F0AAD89F275}"/>
              </a:ext>
            </a:extLst>
          </p:cNvPr>
          <p:cNvGraphicFramePr>
            <a:graphicFrameLocks noGrp="1"/>
          </p:cNvGraphicFramePr>
          <p:nvPr/>
        </p:nvGraphicFramePr>
        <p:xfrm>
          <a:off x="314113" y="643890"/>
          <a:ext cx="6229773" cy="4980966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293876">
                  <a:extLst>
                    <a:ext uri="{9D8B030D-6E8A-4147-A177-3AD203B41FA5}">
                      <a16:colId xmlns:a16="http://schemas.microsoft.com/office/drawing/2014/main" val="1441026580"/>
                    </a:ext>
                  </a:extLst>
                </a:gridCol>
                <a:gridCol w="1150113">
                  <a:extLst>
                    <a:ext uri="{9D8B030D-6E8A-4147-A177-3AD203B41FA5}">
                      <a16:colId xmlns:a16="http://schemas.microsoft.com/office/drawing/2014/main" val="3282591095"/>
                    </a:ext>
                  </a:extLst>
                </a:gridCol>
                <a:gridCol w="3785784">
                  <a:extLst>
                    <a:ext uri="{9D8B030D-6E8A-4147-A177-3AD203B41FA5}">
                      <a16:colId xmlns:a16="http://schemas.microsoft.com/office/drawing/2014/main" val="3809054462"/>
                    </a:ext>
                  </a:extLst>
                </a:gridCol>
              </a:tblGrid>
              <a:tr h="292998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ecies </a:t>
                      </a:r>
                    </a:p>
                  </a:txBody>
                  <a:tcPr marL="121706" marR="12170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i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Ns</a:t>
                      </a:r>
                    </a:p>
                  </a:txBody>
                  <a:tcPr marL="121706" marR="12170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ordinate</a:t>
                      </a:r>
                    </a:p>
                  </a:txBody>
                  <a:tcPr marL="121706" marR="12170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90457495"/>
                  </a:ext>
                </a:extLst>
              </a:tr>
              <a:tr h="292998">
                <a:tc rowSpan="8">
                  <a:txBody>
                    <a:bodyPr/>
                    <a:lstStyle/>
                    <a:p>
                      <a:pPr algn="ctr"/>
                      <a:r>
                        <a:rPr lang="en-US" sz="1000" i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. </a:t>
                      </a:r>
                      <a:r>
                        <a:rPr lang="en-US" sz="1000" i="1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rapsilosis</a:t>
                      </a:r>
                      <a:endParaRPr lang="en-US" sz="1000" i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00584" marR="100584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121706" marR="12170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605202:209,424-215,647</a:t>
                      </a:r>
                    </a:p>
                  </a:txBody>
                  <a:tcPr marL="121706" marR="12170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77476773"/>
                  </a:ext>
                </a:extLst>
              </a:tr>
              <a:tr h="292998">
                <a:tc vMerge="1">
                  <a:txBody>
                    <a:bodyPr/>
                    <a:lstStyle/>
                    <a:p>
                      <a:pPr algn="ctr"/>
                      <a:endParaRPr 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121706" marR="12170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605203:362,588-368,324</a:t>
                      </a:r>
                    </a:p>
                  </a:txBody>
                  <a:tcPr marL="121706" marR="12170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14451240"/>
                  </a:ext>
                </a:extLst>
              </a:tr>
              <a:tr h="292998">
                <a:tc vMerge="1">
                  <a:txBody>
                    <a:bodyPr/>
                    <a:lstStyle/>
                    <a:p>
                      <a:pPr algn="ctr"/>
                      <a:endParaRPr 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121706" marR="12170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605204:470,757-476,666</a:t>
                      </a:r>
                    </a:p>
                  </a:txBody>
                  <a:tcPr marL="121706" marR="12170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33267737"/>
                  </a:ext>
                </a:extLst>
              </a:tr>
              <a:tr h="292998">
                <a:tc vMerge="1">
                  <a:txBody>
                    <a:bodyPr/>
                    <a:lstStyle/>
                    <a:p>
                      <a:pPr algn="ctr"/>
                      <a:endParaRPr 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121706" marR="12170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605205:1,281,284-1,287,683</a:t>
                      </a:r>
                    </a:p>
                  </a:txBody>
                  <a:tcPr marL="121706" marR="12170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98303469"/>
                  </a:ext>
                </a:extLst>
              </a:tr>
              <a:tr h="292998">
                <a:tc vMerge="1">
                  <a:txBody>
                    <a:bodyPr/>
                    <a:lstStyle/>
                    <a:p>
                      <a:pPr algn="ctr"/>
                      <a:endParaRPr 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</a:p>
                  </a:txBody>
                  <a:tcPr marL="121706" marR="12170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605206:1,309,222-1,314,566</a:t>
                      </a:r>
                    </a:p>
                  </a:txBody>
                  <a:tcPr marL="121706" marR="12170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78138360"/>
                  </a:ext>
                </a:extLst>
              </a:tr>
              <a:tr h="292998">
                <a:tc vMerge="1">
                  <a:txBody>
                    <a:bodyPr/>
                    <a:lstStyle/>
                    <a:p>
                      <a:pPr algn="ctr"/>
                      <a:endParaRPr 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</a:p>
                  </a:txBody>
                  <a:tcPr marL="121706" marR="12170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605207:658,126-664,775</a:t>
                      </a:r>
                    </a:p>
                  </a:txBody>
                  <a:tcPr marL="121706" marR="12170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41760391"/>
                  </a:ext>
                </a:extLst>
              </a:tr>
              <a:tr h="292998">
                <a:tc vMerge="1">
                  <a:txBody>
                    <a:bodyPr/>
                    <a:lstStyle/>
                    <a:p>
                      <a:pPr algn="ctr"/>
                      <a:endParaRPr 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</a:p>
                  </a:txBody>
                  <a:tcPr marL="121706" marR="12170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605208:888,702-891,518</a:t>
                      </a:r>
                    </a:p>
                  </a:txBody>
                  <a:tcPr marL="121706" marR="12170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28798656"/>
                  </a:ext>
                </a:extLst>
              </a:tr>
              <a:tr h="292998">
                <a:tc vMerge="1">
                  <a:txBody>
                    <a:bodyPr/>
                    <a:lstStyle/>
                    <a:p>
                      <a:pPr algn="ctr"/>
                      <a:endParaRPr 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</a:p>
                  </a:txBody>
                  <a:tcPr marL="121706" marR="12170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605209:470,949-477,776</a:t>
                      </a:r>
                    </a:p>
                  </a:txBody>
                  <a:tcPr marL="121706" marR="12170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28424942"/>
                  </a:ext>
                </a:extLst>
              </a:tr>
              <a:tr h="292998">
                <a:tc rowSpan="8">
                  <a:txBody>
                    <a:bodyPr/>
                    <a:lstStyle/>
                    <a:p>
                      <a:pPr algn="ctr"/>
                      <a:r>
                        <a:rPr lang="en-US" sz="1000" i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. </a:t>
                      </a:r>
                      <a:r>
                        <a:rPr lang="en-US" sz="1000" i="1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ubliniensis</a:t>
                      </a:r>
                      <a:endParaRPr lang="en-US" sz="1000" i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00584" marR="100584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121706" marR="12170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r1:1,594,163-1,611,889</a:t>
                      </a:r>
                    </a:p>
                  </a:txBody>
                  <a:tcPr marL="121706" marR="12170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17413156"/>
                  </a:ext>
                </a:extLst>
              </a:tr>
              <a:tr h="29299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121706" marR="12170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r2:1,942,441-1,947,217</a:t>
                      </a:r>
                    </a:p>
                  </a:txBody>
                  <a:tcPr marL="121706" marR="12170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15699305"/>
                  </a:ext>
                </a:extLst>
              </a:tr>
              <a:tr h="292998">
                <a:tc vMerge="1">
                  <a:txBody>
                    <a:bodyPr/>
                    <a:lstStyle/>
                    <a:p>
                      <a:pPr algn="ctr"/>
                      <a:endParaRPr 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121706" marR="12170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r3:870,922-876,511</a:t>
                      </a:r>
                    </a:p>
                  </a:txBody>
                  <a:tcPr marL="121706" marR="12170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41086430"/>
                  </a:ext>
                </a:extLst>
              </a:tr>
              <a:tr h="292998">
                <a:tc vMerge="1">
                  <a:txBody>
                    <a:bodyPr/>
                    <a:lstStyle/>
                    <a:p>
                      <a:pPr algn="ctr"/>
                      <a:endParaRPr 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121706" marR="12170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r4:1,028,245-1,036,391</a:t>
                      </a:r>
                    </a:p>
                  </a:txBody>
                  <a:tcPr marL="121706" marR="12170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9801728"/>
                  </a:ext>
                </a:extLst>
              </a:tr>
              <a:tr h="292998">
                <a:tc vMerge="1">
                  <a:txBody>
                    <a:bodyPr/>
                    <a:lstStyle/>
                    <a:p>
                      <a:pPr algn="ctr"/>
                      <a:endParaRPr 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</a:p>
                  </a:txBody>
                  <a:tcPr marL="121706" marR="12170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r5:491,715-501,426</a:t>
                      </a:r>
                    </a:p>
                  </a:txBody>
                  <a:tcPr marL="121706" marR="12170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48665239"/>
                  </a:ext>
                </a:extLst>
              </a:tr>
              <a:tr h="292998">
                <a:tc vMerge="1">
                  <a:txBody>
                    <a:bodyPr/>
                    <a:lstStyle/>
                    <a:p>
                      <a:pPr algn="ctr"/>
                      <a:endParaRPr 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</a:p>
                  </a:txBody>
                  <a:tcPr marL="121706" marR="12170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r6:1,001,458-1,009,565</a:t>
                      </a:r>
                    </a:p>
                  </a:txBody>
                  <a:tcPr marL="121706" marR="12170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58138428"/>
                  </a:ext>
                </a:extLst>
              </a:tr>
              <a:tr h="292998">
                <a:tc vMerge="1">
                  <a:txBody>
                    <a:bodyPr/>
                    <a:lstStyle/>
                    <a:p>
                      <a:pPr algn="ctr"/>
                      <a:endParaRPr 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</a:p>
                  </a:txBody>
                  <a:tcPr marL="121706" marR="12170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r7:434,210-439,177</a:t>
                      </a:r>
                    </a:p>
                  </a:txBody>
                  <a:tcPr marL="121706" marR="12170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74115025"/>
                  </a:ext>
                </a:extLst>
              </a:tr>
              <a:tr h="292998">
                <a:tc vMerge="1">
                  <a:txBody>
                    <a:bodyPr/>
                    <a:lstStyle/>
                    <a:p>
                      <a:pPr algn="ctr"/>
                      <a:endParaRPr 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</a:p>
                  </a:txBody>
                  <a:tcPr marL="121706" marR="12170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rR:1,713,450-1,722,609</a:t>
                      </a:r>
                    </a:p>
                  </a:txBody>
                  <a:tcPr marL="121706" marR="121706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2829206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8268684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192</Words>
  <Application>Microsoft Macintosh PowerPoint</Application>
  <PresentationFormat>A4 Paper (210x297 mm)</PresentationFormat>
  <Paragraphs>101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rishnendu guin</dc:creator>
  <cp:lastModifiedBy>krishnendu guin</cp:lastModifiedBy>
  <cp:revision>1</cp:revision>
  <dcterms:created xsi:type="dcterms:W3CDTF">2020-05-27T11:05:47Z</dcterms:created>
  <dcterms:modified xsi:type="dcterms:W3CDTF">2020-05-27T11:07:02Z</dcterms:modified>
</cp:coreProperties>
</file>